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4" d="100"/>
          <a:sy n="64" d="100"/>
        </p:scale>
        <p:origin x="-44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0418DE-C17B-0E4E-8ED3-BE5D953DB8F8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D62F78-90F1-BB41-95FB-7C2881A024E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2044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C02D82-33AD-4D56-8ABD-86BDC0213616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080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7851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3294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6923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4551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3610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544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4061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3556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2459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6672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9195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EC872-6934-1F40-8421-0E094DB48881}" type="datetimeFigureOut">
              <a:rPr lang="es-ES" smtClean="0"/>
              <a:t>19/02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69231-8774-2145-A7F6-159C188768D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2650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9193202"/>
              </p:ext>
            </p:extLst>
          </p:nvPr>
        </p:nvGraphicFramePr>
        <p:xfrm>
          <a:off x="1515705" y="435514"/>
          <a:ext cx="6096000" cy="5948680"/>
        </p:xfrm>
        <a:graphic>
          <a:graphicData uri="http://schemas.openxmlformats.org/drawingml/2006/table">
            <a:tbl>
              <a:tblPr firstRow="1" bandRow="1">
                <a:tableStyleId>{0E3FDE45-AF77-4B5C-9715-49D594BDF05E}</a:tableStyleId>
              </a:tblPr>
              <a:tblGrid>
                <a:gridCol w="3048000"/>
                <a:gridCol w="3048000"/>
              </a:tblGrid>
              <a:tr h="370840">
                <a:tc gridSpan="2">
                  <a:txBody>
                    <a:bodyPr/>
                    <a:lstStyle/>
                    <a:p>
                      <a:pPr algn="l"/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Supplementary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t</a:t>
                      </a:r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able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1. </a:t>
                      </a:r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Clinical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and molecular </a:t>
                      </a:r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baseline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characteristics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of </a:t>
                      </a:r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patients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(n=43)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haracteristic</a:t>
                      </a:r>
                      <a:endParaRPr lang="es-ES" sz="1200" b="1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Value</a:t>
                      </a:r>
                      <a:endParaRPr lang="es-ES" sz="1200" b="1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Age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-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years</a:t>
                      </a:r>
                      <a:endParaRPr lang="es-ES" sz="1200" b="1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s-ES" sz="120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30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16-63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Sex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- 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no.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patients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(%)</a:t>
                      </a:r>
                      <a:endParaRPr lang="es-ES" sz="1200" b="1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Male</a:t>
                      </a:r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 </a:t>
                      </a:r>
                    </a:p>
                    <a:p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Femal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20 (47)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23 (53)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White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blood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ell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ount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/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ul</a:t>
                      </a:r>
                      <a:endParaRPr lang="es-ES" sz="1200" b="1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s-ES" sz="120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 smtClean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11200 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125-412900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Neutrophils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ount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/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ul</a:t>
                      </a:r>
                      <a:endParaRPr lang="es-ES" sz="1200" b="1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s-ES" sz="120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900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19-291300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Hemoglobin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(g/dl)</a:t>
                      </a:r>
                    </a:p>
                    <a:p>
                      <a:r>
                        <a:rPr lang="es-ES" sz="120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8,4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4,15-15,7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Platelet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baseline="0" dirty="0" err="1" smtClean="0">
                          <a:latin typeface="Arial"/>
                          <a:cs typeface="Arial"/>
                        </a:rPr>
                        <a:t>count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/</a:t>
                      </a:r>
                      <a:r>
                        <a:rPr lang="es-ES" sz="1200" b="1" baseline="0" dirty="0" err="1" smtClean="0">
                          <a:latin typeface="Arial"/>
                          <a:cs typeface="Arial"/>
                        </a:rPr>
                        <a:t>ul</a:t>
                      </a:r>
                      <a:endParaRPr lang="es-ES" sz="1200" b="1" baseline="0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baseline="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24000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6000-682000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Bone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Marrow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blast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ount</a:t>
                      </a:r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 - (%)</a:t>
                      </a:r>
                    </a:p>
                    <a:p>
                      <a:r>
                        <a:rPr lang="es-ES" sz="1200" dirty="0" smtClean="0">
                          <a:latin typeface="Arial"/>
                          <a:cs typeface="Arial"/>
                        </a:rPr>
                        <a:t>Median</a:t>
                      </a:r>
                    </a:p>
                    <a:p>
                      <a:r>
                        <a:rPr lang="es-ES" sz="1200" dirty="0" err="1" smtClean="0">
                          <a:latin typeface="Arial"/>
                          <a:cs typeface="Arial"/>
                        </a:rPr>
                        <a:t>range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82 </a:t>
                      </a: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20-95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Cytogenetic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s-ES" sz="1200" b="1" baseline="0" dirty="0" err="1" smtClean="0">
                          <a:latin typeface="Arial"/>
                          <a:cs typeface="Arial"/>
                        </a:rPr>
                        <a:t>abnormalities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 </a:t>
                      </a:r>
                    </a:p>
                    <a:p>
                      <a:r>
                        <a:rPr lang="es-ES" sz="1200" b="1" dirty="0" smtClean="0">
                          <a:latin typeface="Arial"/>
                          <a:cs typeface="Arial"/>
                        </a:rPr>
                        <a:t>no. </a:t>
                      </a:r>
                      <a:r>
                        <a:rPr lang="es-ES" sz="1200" b="1" dirty="0" err="1" smtClean="0">
                          <a:latin typeface="Arial"/>
                          <a:cs typeface="Arial"/>
                        </a:rPr>
                        <a:t>patients</a:t>
                      </a:r>
                      <a:r>
                        <a:rPr lang="es-ES" sz="1200" b="1" baseline="0" dirty="0" smtClean="0">
                          <a:latin typeface="Arial"/>
                          <a:cs typeface="Arial"/>
                        </a:rPr>
                        <a:t> (%)</a:t>
                      </a:r>
                    </a:p>
                    <a:p>
                      <a:r>
                        <a:rPr lang="es-ES" sz="1200" baseline="0" dirty="0" smtClean="0">
                          <a:latin typeface="Arial"/>
                          <a:cs typeface="Arial"/>
                        </a:rPr>
                        <a:t>t(9;22)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endParaRPr lang="es-ES" sz="1200" dirty="0" smtClean="0">
                        <a:latin typeface="Arial"/>
                        <a:cs typeface="Arial"/>
                      </a:endParaRPr>
                    </a:p>
                    <a:p>
                      <a:pPr algn="ctr"/>
                      <a:r>
                        <a:rPr lang="es-ES" sz="1200" dirty="0" smtClean="0">
                          <a:latin typeface="Arial"/>
                          <a:cs typeface="Arial"/>
                        </a:rPr>
                        <a:t>5 (12) </a:t>
                      </a:r>
                      <a:endParaRPr lang="es-E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351162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Macintosh PowerPoint</Application>
  <PresentationFormat>Presentación en pantalla (4:3)</PresentationFormat>
  <Paragraphs>5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ataly Cruz</dc:creator>
  <cp:lastModifiedBy>Nataly Cruz</cp:lastModifiedBy>
  <cp:revision>1</cp:revision>
  <dcterms:created xsi:type="dcterms:W3CDTF">2016-02-19T17:28:51Z</dcterms:created>
  <dcterms:modified xsi:type="dcterms:W3CDTF">2016-02-19T17:29:20Z</dcterms:modified>
</cp:coreProperties>
</file>